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4" r:id="rId2"/>
    <p:sldId id="257" r:id="rId3"/>
    <p:sldId id="265" r:id="rId4"/>
    <p:sldId id="266" r:id="rId5"/>
    <p:sldId id="267" r:id="rId6"/>
    <p:sldId id="268" r:id="rId7"/>
    <p:sldId id="258" r:id="rId8"/>
    <p:sldId id="269" r:id="rId9"/>
    <p:sldId id="262" r:id="rId10"/>
    <p:sldId id="263" r:id="rId11"/>
    <p:sldId id="270" r:id="rId12"/>
    <p:sldId id="271" r:id="rId1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5538"/>
    <p:restoredTop sz="94726"/>
  </p:normalViewPr>
  <p:slideViewPr>
    <p:cSldViewPr snapToGrid="0">
      <p:cViewPr varScale="1">
        <p:scale>
          <a:sx n="40" d="100"/>
          <a:sy n="40" d="100"/>
        </p:scale>
        <p:origin x="216" y="19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36AC5C-BC4E-7979-7DF4-93AFCD726BB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1DA2D4A-6196-EFE5-1264-BF12B598947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60AC62-84DA-475D-1474-78340B648F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87088-CFE5-A34C-A024-13696863EF30}" type="datetimeFigureOut">
              <a:rPr lang="en-US" smtClean="0"/>
              <a:t>7/31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6656D4-6630-34B8-5AEC-4DC701D55F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FFCE1C-39D2-313C-3132-DB8C8BA67E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8559E-1E5B-B546-9FE7-9FCFB21197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52417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ABE2E4-0B96-2767-A8EC-F6E5CFDEB1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C5D74AB-1721-83E7-437C-EAFDE39086C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59B55B-6D4C-E250-4F20-13DA93F17D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87088-CFE5-A34C-A024-13696863EF30}" type="datetimeFigureOut">
              <a:rPr lang="en-US" smtClean="0"/>
              <a:t>7/31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B50AA6-88A2-1528-98AF-C2046207B6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A020E81-E876-739C-9566-9ED5E8E1E1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8559E-1E5B-B546-9FE7-9FCFB21197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63491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8F21C68-49E4-DBE8-217C-3C177AB3ED3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05C8F15-7E6A-13F4-5371-7DFDC8B9312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3C27FE7-AFFD-12A1-50BD-4DC7F82E66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87088-CFE5-A34C-A024-13696863EF30}" type="datetimeFigureOut">
              <a:rPr lang="en-US" smtClean="0"/>
              <a:t>7/31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1F0FB42-6650-F795-4A93-D25C6B1655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1DDEF2-F453-57A0-14E1-FFFFEDF47A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8559E-1E5B-B546-9FE7-9FCFB21197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08881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FB2226-E937-2357-57E0-E47E66CC25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977243D-38C8-3183-0D1C-93EC591B111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C7C8599-FBD8-B20C-8301-0A09D23117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87088-CFE5-A34C-A024-13696863EF30}" type="datetimeFigureOut">
              <a:rPr lang="en-US" smtClean="0"/>
              <a:t>7/31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2592F3-4B10-84EB-A485-930C22C903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9CA417-815E-AD97-DD75-8312727666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8559E-1E5B-B546-9FE7-9FCFB21197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05525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A3D851-DFD9-B954-67BD-C909CEB6BA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D0D0025-060A-30D6-0893-F452BB5D682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B79DC94-FE83-E2BC-8990-99D1C150EF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87088-CFE5-A34C-A024-13696863EF30}" type="datetimeFigureOut">
              <a:rPr lang="en-US" smtClean="0"/>
              <a:t>7/31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AA2309-AA14-FC3D-9DB4-C53070E09D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27DB54-DCA9-6323-BCB5-D894BD7FB2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8559E-1E5B-B546-9FE7-9FCFB21197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88850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D778C4-4AA0-A375-356D-62D419736D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F38B962-64D3-CA7E-C807-465E1BC66D9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F9EE10B-F0EB-FAD6-BA4C-58B97668AE8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25E7E53-B1DE-DAB1-2B41-35C2558E77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87088-CFE5-A34C-A024-13696863EF30}" type="datetimeFigureOut">
              <a:rPr lang="en-US" smtClean="0"/>
              <a:t>7/31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B229946-0A1F-8139-728A-81E7FEE6FA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36935C5-E293-1E39-8EEB-F2781025ED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8559E-1E5B-B546-9FE7-9FCFB21197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49891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D959E4-7C59-6923-14FD-BEFDE930E5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8904A94-9107-D986-E3F7-1773B4D166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4E83A93-5C80-CE26-7676-A6D600D6B80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E4CB963-E325-06AB-6092-35E2ED8C7BA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7120352-7373-F9C7-DBF8-6FAF942B14B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7683884-C47A-2978-9997-02A5D64251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87088-CFE5-A34C-A024-13696863EF30}" type="datetimeFigureOut">
              <a:rPr lang="en-US" smtClean="0"/>
              <a:t>7/31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2BC1835-00B3-62AC-42D5-96E4CA26F8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E668775-FE21-76E5-37D4-2824E1504E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8559E-1E5B-B546-9FE7-9FCFB21197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55928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BAB8EC-CEBF-E3F9-9F69-2AB58A2A5A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70ACF87-1821-F45F-2AFB-AD3118EF5F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87088-CFE5-A34C-A024-13696863EF30}" type="datetimeFigureOut">
              <a:rPr lang="en-US" smtClean="0"/>
              <a:t>7/31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5B35C5F-41D2-01CE-AE23-3F1D4105D3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3E7DBF7-53DD-C890-FCB0-5549C6F18E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8559E-1E5B-B546-9FE7-9FCFB21197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35190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5AE70DC-7D5D-1365-AAA6-D664511323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87088-CFE5-A34C-A024-13696863EF30}" type="datetimeFigureOut">
              <a:rPr lang="en-US" smtClean="0"/>
              <a:t>7/31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3360A5D-0EB6-7C58-DAE6-85EC3A1058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D4AABDA-8055-BB7A-F7EC-E73A8DC4AB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8559E-1E5B-B546-9FE7-9FCFB21197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12007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61A01D-D131-0E4B-B8E1-84B703D58C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9B3797B-C170-1BC8-8147-E4FAAE871ED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73B9D0F-81FD-0DA3-C41C-48F9C2F996E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D396308-4C26-89DC-818E-BAC3B74E5A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87088-CFE5-A34C-A024-13696863EF30}" type="datetimeFigureOut">
              <a:rPr lang="en-US" smtClean="0"/>
              <a:t>7/31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E7B6AE2-D3A1-A8DC-1D46-BDF20AEA1E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09EE7DA-0377-231F-FA71-6C1387EDEF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8559E-1E5B-B546-9FE7-9FCFB21197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5917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FFE46D-13DF-A5DE-BEA3-8BD37C7722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EF5D1D4-D4C2-39C7-F117-FAD9A8C1CCD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8DAF927-628B-D52F-2BE7-1ED023B1870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7C0C9BE-C8B6-7B0E-6E43-CB90CC8236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C87088-CFE5-A34C-A024-13696863EF30}" type="datetimeFigureOut">
              <a:rPr lang="en-US" smtClean="0"/>
              <a:t>7/31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7AFF5EE-3842-4CC7-33B2-0B9C460BF7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79EAF5E-A0F1-D1F6-E58B-EEC1C0AAF9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8559E-1E5B-B546-9FE7-9FCFB21197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70200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AA5E99A-B567-947A-ED68-CB9F262927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1FC0FC2-F290-0F21-4176-EBE9E4FA70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7287FF-61B6-D9AB-6DA5-5474CE91C57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C87088-CFE5-A34C-A024-13696863EF30}" type="datetimeFigureOut">
              <a:rPr lang="en-US" smtClean="0"/>
              <a:t>7/31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621D5B7-4C72-BBD3-DA46-85CBBFE8C21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852AC1-F2EC-BD5A-B0C0-5D0B2FAF0A9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B8559E-1E5B-B546-9FE7-9FCFB21197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79774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Image">
            <a:extLst>
              <a:ext uri="{FF2B5EF4-FFF2-40B4-BE49-F238E27FC236}">
                <a16:creationId xmlns:a16="http://schemas.microsoft.com/office/drawing/2014/main" id="{495471D9-6035-7960-B1EF-E4435BB44C5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14159"/>
            <a:ext cx="12192000" cy="5629682"/>
          </a:xfrm>
          <a:prstGeom prst="rect">
            <a:avLst/>
          </a:prstGeom>
          <a:ln w="12700" cap="flat">
            <a:noFill/>
            <a:miter lim="400000"/>
          </a:ln>
          <a:effectLst/>
        </p:spPr>
      </p:pic>
    </p:spTree>
    <p:extLst>
      <p:ext uri="{BB962C8B-B14F-4D97-AF65-F5344CB8AC3E}">
        <p14:creationId xmlns:p14="http://schemas.microsoft.com/office/powerpoint/2010/main" val="172114594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10962917-D544-2724-097D-599B639A7DDF}"/>
              </a:ext>
            </a:extLst>
          </p:cNvPr>
          <p:cNvSpPr txBox="1"/>
          <p:nvPr/>
        </p:nvSpPr>
        <p:spPr>
          <a:xfrm>
            <a:off x="3048000" y="1736229"/>
            <a:ext cx="6096000" cy="338554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i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Toxicology Screen</a:t>
            </a: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Amphetamines			Negative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Barbiturates	</a:t>
            </a:r>
            <a:r>
              <a:rPr lang="en-US" dirty="0">
                <a:latin typeface="Calibri" panose="020F0502020204030204" pitchFamily="34" charset="0"/>
                <a:ea typeface="Times New Roman" panose="02020603050405020304" pitchFamily="18" charset="0"/>
              </a:rPr>
              <a:t>	</a:t>
            </a:r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	Negative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Benzodiazepines			Negative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Cocaine				Negative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Marijuana			Negative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Methadone			Negative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Methamphetamine			Positive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Opiates				Negative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Phencyclidine			Negative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Tricyclic antidepressants		Negative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303719681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Image">
            <a:extLst>
              <a:ext uri="{FF2B5EF4-FFF2-40B4-BE49-F238E27FC236}">
                <a16:creationId xmlns:a16="http://schemas.microsoft.com/office/drawing/2014/main" id="{640C5483-99A4-3F4B-727C-EAFE8AB8CD0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32530" y="0"/>
            <a:ext cx="6726939" cy="6872833"/>
          </a:xfrm>
          <a:prstGeom prst="rect">
            <a:avLst/>
          </a:prstGeom>
          <a:ln w="12700" cap="flat">
            <a:noFill/>
            <a:miter lim="400000"/>
          </a:ln>
          <a:effectLst/>
        </p:spPr>
      </p:pic>
    </p:spTree>
    <p:extLst>
      <p:ext uri="{BB962C8B-B14F-4D97-AF65-F5344CB8AC3E}">
        <p14:creationId xmlns:p14="http://schemas.microsoft.com/office/powerpoint/2010/main" val="2420309815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Image">
            <a:extLst>
              <a:ext uri="{FF2B5EF4-FFF2-40B4-BE49-F238E27FC236}">
                <a16:creationId xmlns:a16="http://schemas.microsoft.com/office/drawing/2014/main" id="{C7CD8A8A-D175-0C8D-FABC-71A114D17A0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2548217" y="20703"/>
            <a:ext cx="7095565" cy="6816594"/>
          </a:xfrm>
          <a:prstGeom prst="rect">
            <a:avLst/>
          </a:prstGeom>
          <a:ln w="12700" cap="flat">
            <a:noFill/>
            <a:miter lim="400000"/>
          </a:ln>
          <a:effectLst/>
        </p:spPr>
      </p:pic>
    </p:spTree>
    <p:extLst>
      <p:ext uri="{BB962C8B-B14F-4D97-AF65-F5344CB8AC3E}">
        <p14:creationId xmlns:p14="http://schemas.microsoft.com/office/powerpoint/2010/main" val="19744621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C96A7B68-03E1-FC5A-5553-E1628DB54314}"/>
              </a:ext>
            </a:extLst>
          </p:cNvPr>
          <p:cNvSpPr txBox="1"/>
          <p:nvPr/>
        </p:nvSpPr>
        <p:spPr>
          <a:xfrm>
            <a:off x="2483223" y="1954305"/>
            <a:ext cx="7225553" cy="267765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r>
              <a:rPr lang="en-US" sz="2400" b="1" i="1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Complete blood count (CBC)</a:t>
            </a: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endParaRPr lang="en-US" sz="2400" b="1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r>
              <a:rPr lang="en-US" sz="24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White blood count (WBC)		9.6 x 1000/mm</a:t>
            </a:r>
            <a:r>
              <a:rPr lang="en-US" sz="2400" baseline="300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3</a:t>
            </a:r>
            <a:endParaRPr lang="en-US" sz="24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r>
              <a:rPr lang="en-US" sz="24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Hemoglobin (Hgb)				10.1 g/dL</a:t>
            </a:r>
            <a:endParaRPr lang="en-US" sz="24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r>
              <a:rPr lang="en-US" sz="24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Hematocrit (HCT)				30.3%</a:t>
            </a:r>
            <a:endParaRPr lang="en-US" sz="24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r>
              <a:rPr lang="en-US" sz="24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Mean Corpuscular Volume (MCV)	105 </a:t>
            </a:r>
            <a:r>
              <a:rPr lang="en-US" sz="2400" dirty="0" err="1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fL</a:t>
            </a:r>
            <a:endParaRPr lang="en-US" sz="24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r>
              <a:rPr lang="en-US" sz="24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Platelet (</a:t>
            </a:r>
            <a:r>
              <a:rPr lang="en-US" sz="2400" dirty="0" err="1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Plt</a:t>
            </a:r>
            <a:r>
              <a:rPr lang="en-US" sz="24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)				77 x 1000/mm</a:t>
            </a:r>
            <a:r>
              <a:rPr lang="en-US" sz="2400" baseline="300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3</a:t>
            </a:r>
            <a:endParaRPr lang="en-US" sz="24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349046525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C96A7B68-03E1-FC5A-5553-E1628DB54314}"/>
              </a:ext>
            </a:extLst>
          </p:cNvPr>
          <p:cNvSpPr txBox="1"/>
          <p:nvPr/>
        </p:nvSpPr>
        <p:spPr>
          <a:xfrm>
            <a:off x="2483223" y="428178"/>
            <a:ext cx="7225553" cy="600164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r>
              <a:rPr lang="en-US" sz="2400" b="1" i="1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Comprehensive metabolic panel (CMP)</a:t>
            </a: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endParaRPr lang="en-US" sz="2400" dirty="0">
              <a:effectLst/>
              <a:latin typeface="Calibri" panose="020F0502020204030204" pitchFamily="34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r>
              <a:rPr lang="en-US" sz="24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Sodium					129 </a:t>
            </a:r>
            <a:r>
              <a:rPr lang="en-US" sz="2400" dirty="0" err="1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mEq</a:t>
            </a:r>
            <a:r>
              <a:rPr lang="en-US" sz="24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/L 	</a:t>
            </a: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r>
              <a:rPr lang="en-US" sz="24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Potassium					3.2 </a:t>
            </a:r>
            <a:r>
              <a:rPr lang="en-US" sz="2400" dirty="0" err="1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mEq</a:t>
            </a:r>
            <a:r>
              <a:rPr lang="en-US" sz="24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/L</a:t>
            </a: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r>
              <a:rPr lang="en-US" sz="24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Chloride					82 </a:t>
            </a:r>
            <a:r>
              <a:rPr lang="en-US" sz="2400" dirty="0" err="1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mEq</a:t>
            </a:r>
            <a:r>
              <a:rPr lang="en-US" sz="24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/L	</a:t>
            </a: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r>
              <a:rPr lang="en-US" sz="24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CO2					17 mmol/L</a:t>
            </a: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r>
              <a:rPr lang="en-US" sz="24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Blood Urea Nitrogen (BUN)		40 mg/dL 	</a:t>
            </a: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r>
              <a:rPr lang="en-US" sz="24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Creatinine (Cr)				2.0 mg/dL 	</a:t>
            </a: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r>
              <a:rPr lang="en-US" sz="24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Glucose					77 mg/dL</a:t>
            </a: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r>
              <a:rPr lang="en-US" sz="24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Calcium					9.0 mg/dL</a:t>
            </a: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r>
              <a:rPr lang="en-US" sz="24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Total Protein				5.5 g/dL</a:t>
            </a: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r>
              <a:rPr lang="en-US" sz="24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Albumin					2.8 g/dL</a:t>
            </a: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r>
              <a:rPr lang="en-US" sz="24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Total bilirubin				1.5 mg/dL</a:t>
            </a: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r>
              <a:rPr lang="en-US" sz="24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Alkaline phosphate			250 units/L</a:t>
            </a: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r>
              <a:rPr lang="en-US" sz="24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Aspartate aminotransferase (AST)	48 units/L</a:t>
            </a: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r>
              <a:rPr lang="en-US" sz="24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Alanine aminotransferase (ALT)	96 units/L</a:t>
            </a:r>
          </a:p>
        </p:txBody>
      </p:sp>
    </p:spTree>
    <p:extLst>
      <p:ext uri="{BB962C8B-B14F-4D97-AF65-F5344CB8AC3E}">
        <p14:creationId xmlns:p14="http://schemas.microsoft.com/office/powerpoint/2010/main" val="334344724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C96A7B68-03E1-FC5A-5553-E1628DB54314}"/>
              </a:ext>
            </a:extLst>
          </p:cNvPr>
          <p:cNvSpPr txBox="1"/>
          <p:nvPr/>
        </p:nvSpPr>
        <p:spPr>
          <a:xfrm>
            <a:off x="2483223" y="3198167"/>
            <a:ext cx="7225553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r>
              <a:rPr lang="en-US" sz="24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Lactate					1.2 mmol/L</a:t>
            </a:r>
            <a:endParaRPr lang="en-US" sz="24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98361943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C96A7B68-03E1-FC5A-5553-E1628DB54314}"/>
              </a:ext>
            </a:extLst>
          </p:cNvPr>
          <p:cNvSpPr txBox="1"/>
          <p:nvPr/>
        </p:nvSpPr>
        <p:spPr>
          <a:xfrm>
            <a:off x="2483223" y="3198167"/>
            <a:ext cx="7225553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r>
              <a:rPr lang="en-US" sz="24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Magnesium					1.5 </a:t>
            </a:r>
            <a:r>
              <a:rPr lang="en-US" sz="2400" dirty="0" err="1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mEq</a:t>
            </a:r>
            <a:r>
              <a:rPr lang="en-US" sz="24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/L</a:t>
            </a:r>
            <a:endParaRPr lang="en-US" sz="24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82367009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C96A7B68-03E1-FC5A-5553-E1628DB54314}"/>
              </a:ext>
            </a:extLst>
          </p:cNvPr>
          <p:cNvSpPr txBox="1"/>
          <p:nvPr/>
        </p:nvSpPr>
        <p:spPr>
          <a:xfrm>
            <a:off x="2483223" y="1954305"/>
            <a:ext cx="7225553" cy="230832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r>
              <a:rPr lang="en-US" sz="2400" b="1" i="1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Coagulation Panel</a:t>
            </a: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endParaRPr lang="en-US" sz="2400" dirty="0">
              <a:effectLst/>
              <a:latin typeface="Calibri" panose="020F0502020204030204" pitchFamily="34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r>
              <a:rPr lang="en-US" sz="24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International normalized ratio 		1.3</a:t>
            </a: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r>
              <a:rPr lang="en-US" sz="24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Prothrombin time 				14 seconds</a:t>
            </a: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r>
              <a:rPr lang="en-US" sz="24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Activated partial thromboplastin time 	32 seconds</a:t>
            </a: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endParaRPr lang="en-US" sz="2400" dirty="0">
              <a:effectLst/>
              <a:latin typeface="Calibri" panose="020F0502020204030204" pitchFamily="34" charset="0"/>
              <a:ea typeface="Arial Unicode MS" panose="020B0604020202020204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6483958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A2EA58D7-E9E3-1AA1-49BC-10FF15531373}"/>
              </a:ext>
            </a:extLst>
          </p:cNvPr>
          <p:cNvSpPr txBox="1"/>
          <p:nvPr/>
        </p:nvSpPr>
        <p:spPr>
          <a:xfrm>
            <a:off x="3048000" y="3110317"/>
            <a:ext cx="60960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i="1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Lipase	</a:t>
            </a:r>
            <a:r>
              <a:rPr lang="en-US" sz="24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			67 units/L</a:t>
            </a:r>
            <a:endParaRPr lang="en-US" sz="24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322482775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A2EA58D7-E9E3-1AA1-49BC-10FF15531373}"/>
              </a:ext>
            </a:extLst>
          </p:cNvPr>
          <p:cNvSpPr txBox="1"/>
          <p:nvPr/>
        </p:nvSpPr>
        <p:spPr>
          <a:xfrm>
            <a:off x="3048000" y="2274838"/>
            <a:ext cx="6096000" cy="230832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b="1" i="1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Serum toxicologic drug screen</a:t>
            </a:r>
            <a:endParaRPr lang="en-US" sz="2400" b="1" dirty="0">
              <a:effectLst/>
              <a:latin typeface="Calibri" panose="020F0502020204030204" pitchFamily="34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endParaRPr lang="en-US" sz="2400" dirty="0">
              <a:effectLst/>
              <a:latin typeface="Calibri" panose="020F0502020204030204" pitchFamily="34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EtOH				Negative</a:t>
            </a: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Salicylate			Negative</a:t>
            </a: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4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Acetaminophen 		Negative</a:t>
            </a: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endParaRPr lang="en-US" sz="2400" i="1" dirty="0">
              <a:effectLst/>
              <a:latin typeface="Calibri" panose="020F0502020204030204" pitchFamily="34" charset="0"/>
              <a:ea typeface="Arial Unicode MS" panose="020B0604020202020204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14812639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C03C00AA-3A96-1ACE-F313-8A208786BDD9}"/>
              </a:ext>
            </a:extLst>
          </p:cNvPr>
          <p:cNvSpPr txBox="1"/>
          <p:nvPr/>
        </p:nvSpPr>
        <p:spPr>
          <a:xfrm>
            <a:off x="3048000" y="1043731"/>
            <a:ext cx="6096000" cy="477053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i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Urinalysis</a:t>
            </a:r>
            <a:endParaRPr lang="en-US" sz="1600" b="1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endParaRPr lang="en-US" sz="1800" dirty="0">
              <a:solidFill>
                <a:srgbClr val="000000"/>
              </a:solidFill>
              <a:effectLst/>
              <a:latin typeface="Calibri" panose="020F0502020204030204" pitchFamily="34" charset="0"/>
              <a:ea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b-HCG	</a:t>
            </a:r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</a:rPr>
              <a:t>	</a:t>
            </a: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		Negative</a:t>
            </a: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Color				Yellow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Appearance			Clear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Specific gravity			1.500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Leukocyte esterase			Negative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Nitrites				Negative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Blood				None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Protein			</a:t>
            </a:r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</a:rPr>
              <a:t>	</a:t>
            </a: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2+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Ketones				2+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Glucose				Negative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Bilirubin				Negative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White blood cells			0-5 WBCs/HPF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Red blood cells			0-5 RBCs/HPF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Squamous epithelial cells		0-5 cells/HPF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33910829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438</Words>
  <Application>Microsoft Macintosh PowerPoint</Application>
  <PresentationFormat>Widescreen</PresentationFormat>
  <Paragraphs>65</Paragraphs>
  <Slides>1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oohey, Shannon</dc:creator>
  <cp:lastModifiedBy>Toohey, Shannon</cp:lastModifiedBy>
  <cp:revision>1</cp:revision>
  <dcterms:created xsi:type="dcterms:W3CDTF">2023-07-31T18:40:00Z</dcterms:created>
  <dcterms:modified xsi:type="dcterms:W3CDTF">2023-07-31T18:46:48Z</dcterms:modified>
</cp:coreProperties>
</file>